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9"/>
  </p:notesMasterIdLst>
  <p:sldIdLst>
    <p:sldId id="256" r:id="rId2"/>
    <p:sldId id="438" r:id="rId3"/>
    <p:sldId id="439" r:id="rId4"/>
    <p:sldId id="437" r:id="rId5"/>
    <p:sldId id="429" r:id="rId6"/>
    <p:sldId id="435" r:id="rId7"/>
    <p:sldId id="440" r:id="rId8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FE0F4473-FC58-456D-BEB5-3427907B16D8}" v="10" dt="2024-03-28T22:48:38.294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>
        <p:scale>
          <a:sx n="100" d="100"/>
          <a:sy n="100" d="100"/>
        </p:scale>
        <p:origin x="990" y="3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5" Type="http://schemas.microsoft.com/office/2015/10/relationships/revisionInfo" Target="revisionInfo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Relationship Id="rId14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Barrientos Toro,Elizve N" userId="389f3ba2-0cd4-48d4-9b99-f4cca14c63ca" providerId="ADAL" clId="{FE0F4473-FC58-456D-BEB5-3427907B16D8}"/>
    <pc:docChg chg="undo redo custSel modSld">
      <pc:chgData name="Barrientos Toro,Elizve N" userId="389f3ba2-0cd4-48d4-9b99-f4cca14c63ca" providerId="ADAL" clId="{FE0F4473-FC58-456D-BEB5-3427907B16D8}" dt="2024-03-29T14:29:58.175" v="363" actId="313"/>
      <pc:docMkLst>
        <pc:docMk/>
      </pc:docMkLst>
      <pc:sldChg chg="modSp mod">
        <pc:chgData name="Barrientos Toro,Elizve N" userId="389f3ba2-0cd4-48d4-9b99-f4cca14c63ca" providerId="ADAL" clId="{FE0F4473-FC58-456D-BEB5-3427907B16D8}" dt="2024-03-29T14:29:58.175" v="363" actId="313"/>
        <pc:sldMkLst>
          <pc:docMk/>
          <pc:sldMk cId="2258450559" sldId="437"/>
        </pc:sldMkLst>
        <pc:spChg chg="mod">
          <ac:chgData name="Barrientos Toro,Elizve N" userId="389f3ba2-0cd4-48d4-9b99-f4cca14c63ca" providerId="ADAL" clId="{FE0F4473-FC58-456D-BEB5-3427907B16D8}" dt="2024-03-29T14:28:37.568" v="361"/>
          <ac:spMkLst>
            <pc:docMk/>
            <pc:sldMk cId="2258450559" sldId="437"/>
            <ac:spMk id="4" creationId="{4C50A80E-E48A-4BB2-A395-A94267D7E6BC}"/>
          </ac:spMkLst>
        </pc:spChg>
        <pc:spChg chg="mod">
          <ac:chgData name="Barrientos Toro,Elizve N" userId="389f3ba2-0cd4-48d4-9b99-f4cca14c63ca" providerId="ADAL" clId="{FE0F4473-FC58-456D-BEB5-3427907B16D8}" dt="2024-03-29T14:29:58.175" v="363" actId="313"/>
          <ac:spMkLst>
            <pc:docMk/>
            <pc:sldMk cId="2258450559" sldId="437"/>
            <ac:spMk id="10" creationId="{19ABAC05-B25F-4F29-9032-127CD908D653}"/>
          </ac:spMkLst>
        </pc:spChg>
        <pc:graphicFrameChg chg="mod modGraphic">
          <ac:chgData name="Barrientos Toro,Elizve N" userId="389f3ba2-0cd4-48d4-9b99-f4cca14c63ca" providerId="ADAL" clId="{FE0F4473-FC58-456D-BEB5-3427907B16D8}" dt="2024-03-29T14:26:27" v="319" actId="114"/>
          <ac:graphicFrameMkLst>
            <pc:docMk/>
            <pc:sldMk cId="2258450559" sldId="437"/>
            <ac:graphicFrameMk id="2" creationId="{214660D6-A45F-4159-9132-4FA688EFC56F}"/>
          </ac:graphicFrameMkLst>
        </pc:graphicFrameChg>
      </pc:sldChg>
      <pc:sldChg chg="addSp delSp modSp mod">
        <pc:chgData name="Barrientos Toro,Elizve N" userId="389f3ba2-0cd4-48d4-9b99-f4cca14c63ca" providerId="ADAL" clId="{FE0F4473-FC58-456D-BEB5-3427907B16D8}" dt="2024-03-29T14:28:00.534" v="359" actId="20577"/>
        <pc:sldMkLst>
          <pc:docMk/>
          <pc:sldMk cId="1925312796" sldId="438"/>
        </pc:sldMkLst>
        <pc:spChg chg="mod">
          <ac:chgData name="Barrientos Toro,Elizve N" userId="389f3ba2-0cd4-48d4-9b99-f4cca14c63ca" providerId="ADAL" clId="{FE0F4473-FC58-456D-BEB5-3427907B16D8}" dt="2024-03-29T14:28:00.534" v="359" actId="20577"/>
          <ac:spMkLst>
            <pc:docMk/>
            <pc:sldMk cId="1925312796" sldId="438"/>
            <ac:spMk id="4" creationId="{E39C0123-0D87-48D8-B921-9282BF611E8B}"/>
          </ac:spMkLst>
        </pc:spChg>
        <pc:spChg chg="add del">
          <ac:chgData name="Barrientos Toro,Elizve N" userId="389f3ba2-0cd4-48d4-9b99-f4cca14c63ca" providerId="ADAL" clId="{FE0F4473-FC58-456D-BEB5-3427907B16D8}" dt="2024-03-28T22:33:18.784" v="13" actId="22"/>
          <ac:spMkLst>
            <pc:docMk/>
            <pc:sldMk cId="1925312796" sldId="438"/>
            <ac:spMk id="8" creationId="{20E33A67-1D14-0F29-BF9E-1DC58D809429}"/>
          </ac:spMkLst>
        </pc:spChg>
        <pc:spChg chg="mod">
          <ac:chgData name="Barrientos Toro,Elizve N" userId="389f3ba2-0cd4-48d4-9b99-f4cca14c63ca" providerId="ADAL" clId="{FE0F4473-FC58-456D-BEB5-3427907B16D8}" dt="2024-03-29T14:27:04.518" v="340" actId="1076"/>
          <ac:spMkLst>
            <pc:docMk/>
            <pc:sldMk cId="1925312796" sldId="438"/>
            <ac:spMk id="10" creationId="{19ABAC05-B25F-4F29-9032-127CD908D653}"/>
          </ac:spMkLst>
        </pc:spChg>
        <pc:graphicFrameChg chg="mod modGraphic">
          <ac:chgData name="Barrientos Toro,Elizve N" userId="389f3ba2-0cd4-48d4-9b99-f4cca14c63ca" providerId="ADAL" clId="{FE0F4473-FC58-456D-BEB5-3427907B16D8}" dt="2024-03-29T14:26:36.856" v="321" actId="114"/>
          <ac:graphicFrameMkLst>
            <pc:docMk/>
            <pc:sldMk cId="1925312796" sldId="438"/>
            <ac:graphicFrameMk id="2" creationId="{71F393A8-47A6-49C9-9476-6EA5B93F1D42}"/>
          </ac:graphicFrameMkLst>
        </pc:graphicFrameChg>
        <pc:graphicFrameChg chg="add del">
          <ac:chgData name="Barrientos Toro,Elizve N" userId="389f3ba2-0cd4-48d4-9b99-f4cca14c63ca" providerId="ADAL" clId="{FE0F4473-FC58-456D-BEB5-3427907B16D8}" dt="2024-03-28T22:32:41.700" v="7"/>
          <ac:graphicFrameMkLst>
            <pc:docMk/>
            <pc:sldMk cId="1925312796" sldId="438"/>
            <ac:graphicFrameMk id="3" creationId="{D41B7064-9444-4202-DB86-80406B725081}"/>
          </ac:graphicFrameMkLst>
        </pc:graphicFrameChg>
        <pc:graphicFrameChg chg="add del">
          <ac:chgData name="Barrientos Toro,Elizve N" userId="389f3ba2-0cd4-48d4-9b99-f4cca14c63ca" providerId="ADAL" clId="{FE0F4473-FC58-456D-BEB5-3427907B16D8}" dt="2024-03-28T22:32:49.206" v="9"/>
          <ac:graphicFrameMkLst>
            <pc:docMk/>
            <pc:sldMk cId="1925312796" sldId="438"/>
            <ac:graphicFrameMk id="5" creationId="{8001C4B3-879C-F060-3677-F1C2BE7DC9EF}"/>
          </ac:graphicFrameMkLst>
        </pc:graphicFrameChg>
        <pc:graphicFrameChg chg="add mod">
          <ac:chgData name="Barrientos Toro,Elizve N" userId="389f3ba2-0cd4-48d4-9b99-f4cca14c63ca" providerId="ADAL" clId="{FE0F4473-FC58-456D-BEB5-3427907B16D8}" dt="2024-03-28T22:33:05.715" v="11" actId="571"/>
          <ac:graphicFrameMkLst>
            <pc:docMk/>
            <pc:sldMk cId="1925312796" sldId="438"/>
            <ac:graphicFrameMk id="6" creationId="{246F7ECB-2A31-708A-179C-AE65A1521699}"/>
          </ac:graphicFrameMkLst>
        </pc:graphicFrameChg>
      </pc:sldChg>
      <pc:sldChg chg="modSp mod">
        <pc:chgData name="Barrientos Toro,Elizve N" userId="389f3ba2-0cd4-48d4-9b99-f4cca14c63ca" providerId="ADAL" clId="{FE0F4473-FC58-456D-BEB5-3427907B16D8}" dt="2024-03-29T14:28:19.717" v="360"/>
        <pc:sldMkLst>
          <pc:docMk/>
          <pc:sldMk cId="4129012285" sldId="439"/>
        </pc:sldMkLst>
        <pc:spChg chg="mod">
          <ac:chgData name="Barrientos Toro,Elizve N" userId="389f3ba2-0cd4-48d4-9b99-f4cca14c63ca" providerId="ADAL" clId="{FE0F4473-FC58-456D-BEB5-3427907B16D8}" dt="2024-03-29T14:28:19.717" v="360"/>
          <ac:spMkLst>
            <pc:docMk/>
            <pc:sldMk cId="4129012285" sldId="439"/>
            <ac:spMk id="4" creationId="{6184EFB0-5827-47B9-AF83-C204B88116F6}"/>
          </ac:spMkLst>
        </pc:spChg>
        <pc:spChg chg="mod">
          <ac:chgData name="Barrientos Toro,Elizve N" userId="389f3ba2-0cd4-48d4-9b99-f4cca14c63ca" providerId="ADAL" clId="{FE0F4473-FC58-456D-BEB5-3427907B16D8}" dt="2024-03-29T14:25:56.378" v="310" actId="20577"/>
          <ac:spMkLst>
            <pc:docMk/>
            <pc:sldMk cId="4129012285" sldId="439"/>
            <ac:spMk id="10" creationId="{19ABAC05-B25F-4F29-9032-127CD908D653}"/>
          </ac:spMkLst>
        </pc:spChg>
        <pc:graphicFrameChg chg="mod modGraphic">
          <ac:chgData name="Barrientos Toro,Elizve N" userId="389f3ba2-0cd4-48d4-9b99-f4cca14c63ca" providerId="ADAL" clId="{FE0F4473-FC58-456D-BEB5-3427907B16D8}" dt="2024-03-29T14:26:32.664" v="320" actId="114"/>
          <ac:graphicFrameMkLst>
            <pc:docMk/>
            <pc:sldMk cId="4129012285" sldId="439"/>
            <ac:graphicFrameMk id="9" creationId="{909876AA-8A67-4CD5-B3C7-A930CC25DE31}"/>
          </ac:graphicFrameMkLst>
        </pc:graphicFrame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AC83BAD-5EA9-451E-BB0A-24D19EAF40E6}" type="datetimeFigureOut">
              <a:rPr lang="en-US" smtClean="0"/>
              <a:t>3/28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AAF90E2-0E7C-4CF8-ABA2-E1CCDF89D4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767994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And finally in this recent publication…The median overall survival 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B910B01-AF79-43F4-B031-65F5FF212009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336306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And finally in this recent publication…The median overall survival 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B910B01-AF79-43F4-B031-65F5FF212009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833111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5A71A1A-3866-4459-B919-43625A76094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944A88C-EB2F-415D-825E-44ABDA0D14B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D5F656E-BEDE-4503-8D0B-5DAF9C9D9B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4F6C2A-24EB-4DA7-9B52-EBAF20CAFCF7}" type="datetimeFigureOut">
              <a:rPr lang="en-US" smtClean="0"/>
              <a:t>3/28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9F38956-C74B-4CE1-90E9-F1488D4168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1C5EC11-44E9-47CA-8C31-A6DB19D3E8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19C50A-262D-43C6-BE3A-8738A81965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85951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404F466-5852-4515-9829-1D160ADBD28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DBCA9FA-37B9-42BB-ABCB-DE3654204B0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F399824-42C6-4FA2-B577-9D568AE848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4F6C2A-24EB-4DA7-9B52-EBAF20CAFCF7}" type="datetimeFigureOut">
              <a:rPr lang="en-US" smtClean="0"/>
              <a:t>3/28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77616A4-B2A2-4A59-987F-70FF7AC990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D567716-5BC8-462F-AC59-4FB3459486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19C50A-262D-43C6-BE3A-8738A81965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06417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A617AB8-4E0C-4C1E-BD97-7883C5C64DB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3CEC6B5-2BFF-4E05-90D6-E2CAD5326F6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D0F04E4-A1CE-4A11-98A7-7ADF77645D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4F6C2A-24EB-4DA7-9B52-EBAF20CAFCF7}" type="datetimeFigureOut">
              <a:rPr lang="en-US" smtClean="0"/>
              <a:t>3/28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EC05AD1-D121-4DF5-8A60-6FAF40F391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E5F250C-4556-4992-B77A-7E98C9D72C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19C50A-262D-43C6-BE3A-8738A81965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14896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F7FC3E9-0CDB-45A6-801E-2EC42B7D9C6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A168B8B-7906-48F6-B6D2-6A3D6763FA8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BDEDF8D-4796-4D03-8092-1379CB4337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4F6C2A-24EB-4DA7-9B52-EBAF20CAFCF7}" type="datetimeFigureOut">
              <a:rPr lang="en-US" smtClean="0"/>
              <a:t>3/28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1873BC4-D240-4503-BFA6-3F16701CCA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A1A8105-8155-47A5-8E74-74323A02C6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19C50A-262D-43C6-BE3A-8738A81965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28261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3B7582C-2D17-4404-9DD9-85AAB807BBE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CE0263D-0FC9-4EEE-81EC-74E95870643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6D2EC5B-801D-4648-984F-28A1C9553A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4F6C2A-24EB-4DA7-9B52-EBAF20CAFCF7}" type="datetimeFigureOut">
              <a:rPr lang="en-US" smtClean="0"/>
              <a:t>3/28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19905C8-4196-42F4-A477-CF9E2D1009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49B73D5-242F-427F-AFE3-0EFFB1DAE3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19C50A-262D-43C6-BE3A-8738A81965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54140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420A30C-095E-48C4-9D06-68468AFD8C3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C396083-F969-4F1F-8E0C-F0DAB20685F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E54E087-21CD-4F13-8796-8E163A84D80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CAC3899-0163-42ED-8693-A911EEFBBA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4F6C2A-24EB-4DA7-9B52-EBAF20CAFCF7}" type="datetimeFigureOut">
              <a:rPr lang="en-US" smtClean="0"/>
              <a:t>3/28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4C20935-59A1-4A14-8520-3D702A04DA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9B6D939-A1BF-44BB-B942-ADE5AAA9F6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19C50A-262D-43C6-BE3A-8738A81965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56669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EB01C50-3D69-4FB2-9762-1C4A0ACF2A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38E44BF-A334-4DB5-8A93-E87A20D7FFC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ED5F4E4-0781-4165-9707-BDAC79A272E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DB2D938-6B3E-4D89-A174-84EC0A83AB3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3D1067D-3D20-4FF3-BE1B-77446112ECC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631A666-73E9-401B-A9F3-CDF483AF0D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4F6C2A-24EB-4DA7-9B52-EBAF20CAFCF7}" type="datetimeFigureOut">
              <a:rPr lang="en-US" smtClean="0"/>
              <a:t>3/28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F220323-776D-459C-B388-439FB8CE7E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AFF8F8C-4CFA-4C4D-B447-B8B322F7BB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19C50A-262D-43C6-BE3A-8738A81965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52921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B833F71-BBED-4875-8742-D3848521319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9DC279D-3EBF-4041-8BAA-A9CE11143F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4F6C2A-24EB-4DA7-9B52-EBAF20CAFCF7}" type="datetimeFigureOut">
              <a:rPr lang="en-US" smtClean="0"/>
              <a:t>3/28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99B7B4E-4E81-411D-B70B-1E6B63AA5B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D0426EF-FBE9-4C60-8D54-066585B6D4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19C50A-262D-43C6-BE3A-8738A81965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86991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C365B57-C57E-465B-9CB1-FB3A501EF6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4F6C2A-24EB-4DA7-9B52-EBAF20CAFCF7}" type="datetimeFigureOut">
              <a:rPr lang="en-US" smtClean="0"/>
              <a:t>3/28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FC5A125-4DC1-4C16-B9A4-78D726D6ED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D09FE41-7E3A-4912-9AEE-5F7B7C92C0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19C50A-262D-43C6-BE3A-8738A81965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755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D976A08-10BD-4223-A73D-AF11AF8FFAB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F7EDC7B-F3F7-4FBE-99E1-E52E5B2DC8B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A27D598-5674-4A02-B740-EF96E5854F6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16E7AF4-5A6B-49EF-A024-61546F9C2C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4F6C2A-24EB-4DA7-9B52-EBAF20CAFCF7}" type="datetimeFigureOut">
              <a:rPr lang="en-US" smtClean="0"/>
              <a:t>3/28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C668ED0-FD56-4C42-8325-0B77E076FD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9AC70A8-346B-4A7C-A65D-C36ED3F10C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19C50A-262D-43C6-BE3A-8738A81965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36900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E9100D0-D591-4C16-B7A5-5CC10737F05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33ADF8D-CB2C-4CB0-825D-1692F14B676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DD84AA8-12DD-43F4-BC74-3D8451A0F7E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B8B808E-11BF-493D-9B5E-12124392A2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4F6C2A-24EB-4DA7-9B52-EBAF20CAFCF7}" type="datetimeFigureOut">
              <a:rPr lang="en-US" smtClean="0"/>
              <a:t>3/28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560B056-EEEA-47B0-991A-18B009D3BD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8CA7CAD-50E6-4AAB-BF05-8B47A0B560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19C50A-262D-43C6-BE3A-8738A81965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57791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B2CFAD9-7D4C-4848-9158-D3D63801BB7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B8E8840-0DBC-4ACE-80F9-5E208255CDF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C771AA2-8CED-4597-BC1B-366AC61FE93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94F6C2A-24EB-4DA7-9B52-EBAF20CAFCF7}" type="datetimeFigureOut">
              <a:rPr lang="en-US" smtClean="0"/>
              <a:t>3/28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4069A2E-8D94-4846-9EED-A857CF9D0F6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E154F58-91AF-4565-AF8C-B81685DD99A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19C50A-262D-43C6-BE3A-8738A81965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2095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0734632-468A-4F01-96C0-81C8319B5B5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736035" y="1718365"/>
            <a:ext cx="9144000" cy="2387600"/>
          </a:xfrm>
        </p:spPr>
        <p:txBody>
          <a:bodyPr>
            <a:normAutofit/>
          </a:bodyPr>
          <a:lstStyle/>
          <a:p>
            <a:r>
              <a:rPr lang="en-US" b="1" dirty="0"/>
              <a:t>Translational Aspects in Metaplastic Breast Carcinoma</a:t>
            </a:r>
          </a:p>
        </p:txBody>
      </p:sp>
    </p:spTree>
    <p:extLst>
      <p:ext uri="{BB962C8B-B14F-4D97-AF65-F5344CB8AC3E}">
        <p14:creationId xmlns:p14="http://schemas.microsoft.com/office/powerpoint/2010/main" val="105047642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12">
            <a:extLst>
              <a:ext uri="{FF2B5EF4-FFF2-40B4-BE49-F238E27FC236}">
                <a16:creationId xmlns:a16="http://schemas.microsoft.com/office/drawing/2014/main" id="{19ABAC05-B25F-4F29-9032-127CD908D653}"/>
              </a:ext>
            </a:extLst>
          </p:cNvPr>
          <p:cNvSpPr txBox="1"/>
          <p:nvPr/>
        </p:nvSpPr>
        <p:spPr>
          <a:xfrm>
            <a:off x="2879691" y="378931"/>
            <a:ext cx="63176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highlight>
                  <a:srgbClr val="FFFF00"/>
                </a:highlight>
              </a:rPr>
              <a:t>Table 1. Percentage of most frequent mutated genes in MpBC described in different series.</a:t>
            </a:r>
          </a:p>
        </p:txBody>
      </p:sp>
      <p:graphicFrame>
        <p:nvGraphicFramePr>
          <p:cNvPr id="2" name="Table 2">
            <a:extLst>
              <a:ext uri="{FF2B5EF4-FFF2-40B4-BE49-F238E27FC236}">
                <a16:creationId xmlns:a16="http://schemas.microsoft.com/office/drawing/2014/main" id="{71F393A8-47A6-49C9-9476-6EA5B93F1D4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45286844"/>
              </p:ext>
            </p:extLst>
          </p:nvPr>
        </p:nvGraphicFramePr>
        <p:xfrm>
          <a:off x="3431858" y="866027"/>
          <a:ext cx="4926704" cy="4939579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053051">
                  <a:extLst>
                    <a:ext uri="{9D8B030D-6E8A-4147-A177-3AD203B41FA5}">
                      <a16:colId xmlns:a16="http://schemas.microsoft.com/office/drawing/2014/main" val="2446451658"/>
                    </a:ext>
                  </a:extLst>
                </a:gridCol>
                <a:gridCol w="1324262">
                  <a:extLst>
                    <a:ext uri="{9D8B030D-6E8A-4147-A177-3AD203B41FA5}">
                      <a16:colId xmlns:a16="http://schemas.microsoft.com/office/drawing/2014/main" val="470235990"/>
                    </a:ext>
                  </a:extLst>
                </a:gridCol>
                <a:gridCol w="2549391">
                  <a:extLst>
                    <a:ext uri="{9D8B030D-6E8A-4147-A177-3AD203B41FA5}">
                      <a16:colId xmlns:a16="http://schemas.microsoft.com/office/drawing/2014/main" val="671587071"/>
                    </a:ext>
                  </a:extLst>
                </a:gridCol>
              </a:tblGrid>
              <a:tr h="196606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Mutated Gene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Number of Series*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Frequency of Mutations (median) **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46581373"/>
                  </a:ext>
                </a:extLst>
              </a:tr>
              <a:tr h="196606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TP53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1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55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01824122"/>
                  </a:ext>
                </a:extLst>
              </a:tr>
              <a:tr h="196606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PIK3CA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1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34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49067571"/>
                  </a:ext>
                </a:extLst>
              </a:tr>
              <a:tr h="196606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PTEN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10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13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08924757"/>
                  </a:ext>
                </a:extLst>
              </a:tr>
              <a:tr h="196606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HRAS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9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6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54969829"/>
                  </a:ext>
                </a:extLst>
              </a:tr>
              <a:tr h="196606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PIK3R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8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31719856"/>
                  </a:ext>
                </a:extLst>
              </a:tr>
              <a:tr h="196606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NF1 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9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24983451"/>
                  </a:ext>
                </a:extLst>
              </a:tr>
              <a:tr h="196606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ATM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7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10679063"/>
                  </a:ext>
                </a:extLst>
              </a:tr>
              <a:tr h="196606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AKT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1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20386364"/>
                  </a:ext>
                </a:extLst>
              </a:tr>
              <a:tr h="196606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APC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3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84483136"/>
                  </a:ext>
                </a:extLst>
              </a:tr>
              <a:tr h="196606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RB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5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68558833"/>
                  </a:ext>
                </a:extLst>
              </a:tr>
              <a:tr h="196606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KMT2D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15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93335726"/>
                  </a:ext>
                </a:extLst>
              </a:tr>
              <a:tr h="196606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ARID1A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5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91424945"/>
                  </a:ext>
                </a:extLst>
              </a:tr>
              <a:tr h="196606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LRP1B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10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12376249"/>
                  </a:ext>
                </a:extLst>
              </a:tr>
              <a:tr h="196606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SMAD4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15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27226757"/>
                  </a:ext>
                </a:extLst>
              </a:tr>
              <a:tr h="196606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GNAS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5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54342274"/>
                  </a:ext>
                </a:extLst>
              </a:tr>
              <a:tr h="196606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TERT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29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21410274"/>
                  </a:ext>
                </a:extLst>
              </a:tr>
              <a:tr h="196606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BRCA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9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55341155"/>
                  </a:ext>
                </a:extLst>
              </a:tr>
              <a:tr h="196606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KRAS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3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6846904"/>
                  </a:ext>
                </a:extLst>
              </a:tr>
              <a:tr h="22103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BRCA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4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72978951"/>
                  </a:ext>
                </a:extLst>
              </a:tr>
              <a:tr h="196606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RUNX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4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41651225"/>
                  </a:ext>
                </a:extLst>
              </a:tr>
              <a:tr h="196606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CREBBP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5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19901271"/>
                  </a:ext>
                </a:extLst>
              </a:tr>
              <a:tr h="196606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CDH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4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02903783"/>
                  </a:ext>
                </a:extLst>
              </a:tr>
              <a:tr h="196606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JAK3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20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19905629"/>
                  </a:ext>
                </a:extLst>
              </a:tr>
              <a:tr h="196606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 dirty="0">
                          <a:solidFill>
                            <a:schemeClr val="tx1"/>
                          </a:solidFill>
                          <a:effectLst/>
                          <a:highlight>
                            <a:srgbClr val="FFFF00"/>
                          </a:highlight>
                          <a:latin typeface="Calibri" panose="020F0502020204030204" pitchFamily="34" charset="0"/>
                        </a:rPr>
                        <a:t>KMT2C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highlight>
                            <a:srgbClr val="FFFF00"/>
                          </a:highlight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highlight>
                            <a:srgbClr val="FFFF00"/>
                          </a:highlight>
                          <a:latin typeface="Calibri" panose="020F0502020204030204" pitchFamily="34" charset="0"/>
                        </a:rPr>
                        <a:t>8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36332992"/>
                  </a:ext>
                </a:extLst>
              </a:tr>
            </a:tbl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E39C0123-0D87-48D8-B921-9282BF611E8B}"/>
              </a:ext>
            </a:extLst>
          </p:cNvPr>
          <p:cNvSpPr txBox="1"/>
          <p:nvPr/>
        </p:nvSpPr>
        <p:spPr>
          <a:xfrm>
            <a:off x="2736372" y="6017404"/>
            <a:ext cx="6317676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i="0" u="none" strike="noStrike" dirty="0">
                <a:solidFill>
                  <a:srgbClr val="000000"/>
                </a:solidFill>
                <a:effectLst/>
                <a:highlight>
                  <a:srgbClr val="FFFF00"/>
                </a:highlight>
              </a:rPr>
              <a:t>*Informs the number of series that evaluated and reported the mutated gene. **It is the median value of all specified percentages reported in different series.</a:t>
            </a:r>
            <a:endParaRPr lang="en-US" sz="1200" b="1" dirty="0">
              <a:highlight>
                <a:srgbClr val="FFFF00"/>
              </a:highlight>
            </a:endParaRPr>
          </a:p>
        </p:txBody>
      </p:sp>
    </p:spTree>
    <p:extLst>
      <p:ext uri="{BB962C8B-B14F-4D97-AF65-F5344CB8AC3E}">
        <p14:creationId xmlns:p14="http://schemas.microsoft.com/office/powerpoint/2010/main" val="192531279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9" name="Table 9">
            <a:extLst>
              <a:ext uri="{FF2B5EF4-FFF2-40B4-BE49-F238E27FC236}">
                <a16:creationId xmlns:a16="http://schemas.microsoft.com/office/drawing/2014/main" id="{909876AA-8A67-4CD5-B3C7-A930CC25DE3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3981006"/>
              </p:ext>
            </p:extLst>
          </p:nvPr>
        </p:nvGraphicFramePr>
        <p:xfrm>
          <a:off x="3578087" y="748099"/>
          <a:ext cx="4797287" cy="5315742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043184">
                  <a:extLst>
                    <a:ext uri="{9D8B030D-6E8A-4147-A177-3AD203B41FA5}">
                      <a16:colId xmlns:a16="http://schemas.microsoft.com/office/drawing/2014/main" val="226631952"/>
                    </a:ext>
                  </a:extLst>
                </a:gridCol>
                <a:gridCol w="1362326">
                  <a:extLst>
                    <a:ext uri="{9D8B030D-6E8A-4147-A177-3AD203B41FA5}">
                      <a16:colId xmlns:a16="http://schemas.microsoft.com/office/drawing/2014/main" val="1560381545"/>
                    </a:ext>
                  </a:extLst>
                </a:gridCol>
                <a:gridCol w="2391777">
                  <a:extLst>
                    <a:ext uri="{9D8B030D-6E8A-4147-A177-3AD203B41FA5}">
                      <a16:colId xmlns:a16="http://schemas.microsoft.com/office/drawing/2014/main" val="1918628526"/>
                    </a:ext>
                  </a:extLst>
                </a:gridCol>
              </a:tblGrid>
              <a:tr h="188847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utated Gene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umber of Series*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requency of Mutations (median) **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82121013"/>
                  </a:ext>
                </a:extLst>
              </a:tr>
              <a:tr h="18988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LT3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0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7313361"/>
                  </a:ext>
                </a:extLst>
              </a:tr>
              <a:tr h="18988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RBB4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6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77951592"/>
                  </a:ext>
                </a:extLst>
              </a:tr>
              <a:tr h="18988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TN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1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93199407"/>
                  </a:ext>
                </a:extLst>
              </a:tr>
              <a:tr h="18988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DR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8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0264035"/>
                  </a:ext>
                </a:extLst>
              </a:tr>
              <a:tr h="18988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TNNB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.9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82492557"/>
                  </a:ext>
                </a:extLst>
              </a:tr>
              <a:tr h="18988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AT3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57575780"/>
                  </a:ext>
                </a:extLst>
              </a:tr>
              <a:tr h="18988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ISP3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.50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13915517"/>
                  </a:ext>
                </a:extLst>
              </a:tr>
              <a:tr h="18988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SFIR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10811301"/>
                  </a:ext>
                </a:extLst>
              </a:tr>
              <a:tr h="18988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CLO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76172948"/>
                  </a:ext>
                </a:extLst>
              </a:tr>
              <a:tr h="18988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AT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86930874"/>
                  </a:ext>
                </a:extLst>
              </a:tr>
              <a:tr h="18988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HERP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27896176"/>
                  </a:ext>
                </a:extLst>
              </a:tr>
              <a:tr h="18988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CLAF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79720111"/>
                  </a:ext>
                </a:extLst>
              </a:tr>
              <a:tr h="18988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COR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81114420"/>
                  </a:ext>
                </a:extLst>
              </a:tr>
              <a:tr h="18988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ANCM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31821329"/>
                  </a:ext>
                </a:extLst>
              </a:tr>
              <a:tr h="18988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SP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44505149"/>
                  </a:ext>
                </a:extLst>
              </a:tr>
              <a:tr h="18988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D84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30877432"/>
                  </a:ext>
                </a:extLst>
              </a:tr>
              <a:tr h="18988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XIN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98439895"/>
                  </a:ext>
                </a:extLst>
              </a:tr>
              <a:tr h="18988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PEN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25531975"/>
                  </a:ext>
                </a:extLst>
              </a:tr>
              <a:tr h="18988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RBB3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.3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44514612"/>
                  </a:ext>
                </a:extLst>
              </a:tr>
              <a:tr h="18988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DM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.3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18041734"/>
                  </a:ext>
                </a:extLst>
              </a:tr>
              <a:tr h="18988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AP3K1 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00977584"/>
                  </a:ext>
                </a:extLst>
              </a:tr>
              <a:tr h="18988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ASP8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87399593"/>
                  </a:ext>
                </a:extLst>
              </a:tr>
              <a:tr h="18988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ALB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32366595"/>
                  </a:ext>
                </a:extLst>
              </a:tr>
              <a:tr h="18988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LK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50538622"/>
                  </a:ext>
                </a:extLst>
              </a:tr>
              <a:tr h="18988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RBB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19575250"/>
                  </a:ext>
                </a:extLst>
              </a:tr>
              <a:tr h="18988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DGFRA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40723211"/>
                  </a:ext>
                </a:extLst>
              </a:tr>
              <a:tr h="18988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GFR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42043305"/>
                  </a:ext>
                </a:extLst>
              </a:tr>
            </a:tbl>
          </a:graphicData>
        </a:graphic>
      </p:graphicFrame>
      <p:sp>
        <p:nvSpPr>
          <p:cNvPr id="10" name="TextBox 12">
            <a:extLst>
              <a:ext uri="{FF2B5EF4-FFF2-40B4-BE49-F238E27FC236}">
                <a16:creationId xmlns:a16="http://schemas.microsoft.com/office/drawing/2014/main" id="{19ABAC05-B25F-4F29-9032-127CD908D653}"/>
              </a:ext>
            </a:extLst>
          </p:cNvPr>
          <p:cNvSpPr txBox="1"/>
          <p:nvPr/>
        </p:nvSpPr>
        <p:spPr>
          <a:xfrm>
            <a:off x="3466441" y="282788"/>
            <a:ext cx="50393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highlight>
                  <a:srgbClr val="FFFF00"/>
                </a:highlight>
              </a:rPr>
              <a:t>Table 2. Percentage of genes mutated in MpBC described in a single series.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6184EFB0-5827-47B9-AF83-C204B88116F6}"/>
              </a:ext>
            </a:extLst>
          </p:cNvPr>
          <p:cNvSpPr txBox="1"/>
          <p:nvPr/>
        </p:nvSpPr>
        <p:spPr>
          <a:xfrm>
            <a:off x="3078115" y="6163467"/>
            <a:ext cx="6317676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i="0" u="none" strike="noStrike" dirty="0">
                <a:solidFill>
                  <a:srgbClr val="000000"/>
                </a:solidFill>
                <a:effectLst/>
                <a:highlight>
                  <a:srgbClr val="FFFF00"/>
                </a:highlight>
              </a:rPr>
              <a:t>*Informs the number of series that evaluated and reported the mutated gene. **It is the median value of all specified percentages reported in different series.</a:t>
            </a:r>
            <a:endParaRPr lang="en-US" sz="1200" b="1" dirty="0">
              <a:highlight>
                <a:srgbClr val="FFFF00"/>
              </a:highlight>
            </a:endParaRPr>
          </a:p>
        </p:txBody>
      </p:sp>
    </p:spTree>
    <p:extLst>
      <p:ext uri="{BB962C8B-B14F-4D97-AF65-F5344CB8AC3E}">
        <p14:creationId xmlns:p14="http://schemas.microsoft.com/office/powerpoint/2010/main" val="412901228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12">
            <a:extLst>
              <a:ext uri="{FF2B5EF4-FFF2-40B4-BE49-F238E27FC236}">
                <a16:creationId xmlns:a16="http://schemas.microsoft.com/office/drawing/2014/main" id="{19ABAC05-B25F-4F29-9032-127CD908D653}"/>
              </a:ext>
            </a:extLst>
          </p:cNvPr>
          <p:cNvSpPr txBox="1"/>
          <p:nvPr/>
        </p:nvSpPr>
        <p:spPr>
          <a:xfrm>
            <a:off x="3503879" y="207817"/>
            <a:ext cx="61068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highlight>
                  <a:srgbClr val="FFFF00"/>
                </a:highlight>
              </a:rPr>
              <a:t>Table 3. Percentage of genes mutated in MpBC described in a single series (cont.).</a:t>
            </a:r>
            <a:endParaRPr lang="en-US" sz="1200" b="1" dirty="0"/>
          </a:p>
        </p:txBody>
      </p:sp>
      <p:graphicFrame>
        <p:nvGraphicFramePr>
          <p:cNvPr id="2" name="Table 2">
            <a:extLst>
              <a:ext uri="{FF2B5EF4-FFF2-40B4-BE49-F238E27FC236}">
                <a16:creationId xmlns:a16="http://schemas.microsoft.com/office/drawing/2014/main" id="{214660D6-A45F-4159-9132-4FA688EFC56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52615212"/>
              </p:ext>
            </p:extLst>
          </p:nvPr>
        </p:nvGraphicFramePr>
        <p:xfrm>
          <a:off x="3780430" y="674674"/>
          <a:ext cx="4911276" cy="5451674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049753">
                  <a:extLst>
                    <a:ext uri="{9D8B030D-6E8A-4147-A177-3AD203B41FA5}">
                      <a16:colId xmlns:a16="http://schemas.microsoft.com/office/drawing/2014/main" val="2148955911"/>
                    </a:ext>
                  </a:extLst>
                </a:gridCol>
                <a:gridCol w="1320115">
                  <a:extLst>
                    <a:ext uri="{9D8B030D-6E8A-4147-A177-3AD203B41FA5}">
                      <a16:colId xmlns:a16="http://schemas.microsoft.com/office/drawing/2014/main" val="2276860242"/>
                    </a:ext>
                  </a:extLst>
                </a:gridCol>
                <a:gridCol w="2541408">
                  <a:extLst>
                    <a:ext uri="{9D8B030D-6E8A-4147-A177-3AD203B41FA5}">
                      <a16:colId xmlns:a16="http://schemas.microsoft.com/office/drawing/2014/main" val="2394910725"/>
                    </a:ext>
                  </a:extLst>
                </a:gridCol>
              </a:tblGrid>
              <a:tr h="239881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utated Gene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umber of Series*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requency of Mutations (median) **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34401752"/>
                  </a:ext>
                </a:extLst>
              </a:tr>
              <a:tr h="192094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GFR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76577467"/>
                  </a:ext>
                </a:extLst>
              </a:tr>
              <a:tr h="192094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BL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04434617"/>
                  </a:ext>
                </a:extLst>
              </a:tr>
              <a:tr h="192094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YC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5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51383401"/>
                  </a:ext>
                </a:extLst>
              </a:tr>
              <a:tr h="192094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UB1B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55871601"/>
                  </a:ext>
                </a:extLst>
              </a:tr>
              <a:tr h="192094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D3EAP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95860595"/>
                  </a:ext>
                </a:extLst>
              </a:tr>
              <a:tr h="192094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NOT3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34160316"/>
                  </a:ext>
                </a:extLst>
              </a:tr>
              <a:tr h="192094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PS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50158735"/>
                  </a:ext>
                </a:extLst>
              </a:tr>
              <a:tr h="192094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EN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33649547"/>
                  </a:ext>
                </a:extLst>
              </a:tr>
              <a:tr h="192094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PGR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0722369"/>
                  </a:ext>
                </a:extLst>
              </a:tr>
              <a:tr h="192094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PEN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99912008"/>
                  </a:ext>
                </a:extLst>
              </a:tr>
              <a:tr h="192094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TAG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59186106"/>
                  </a:ext>
                </a:extLst>
              </a:tr>
              <a:tr h="217349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BX3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80806151"/>
                  </a:ext>
                </a:extLst>
              </a:tr>
              <a:tr h="192094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BXWE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7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86793954"/>
                  </a:ext>
                </a:extLst>
              </a:tr>
              <a:tr h="192094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highlight>
                            <a:srgbClr val="FFFF00"/>
                          </a:highlight>
                          <a:latin typeface="Calibri" panose="020F0502020204030204" pitchFamily="34" charset="0"/>
                        </a:rPr>
                        <a:t>STK1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FFF00"/>
                          </a:highlight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highlight>
                            <a:srgbClr val="FFFF00"/>
                          </a:highlight>
                          <a:latin typeface="Calibri" panose="020F0502020204030204" pitchFamily="34" charset="0"/>
                        </a:rPr>
                        <a:t>20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26246755"/>
                  </a:ext>
                </a:extLst>
              </a:tr>
              <a:tr h="192094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FFF00"/>
                          </a:highlight>
                          <a:latin typeface="Calibri" panose="020F0502020204030204" pitchFamily="34" charset="0"/>
                        </a:rPr>
                        <a:t>DDX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highlight>
                            <a:srgbClr val="FFFF00"/>
                          </a:highlight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highlight>
                            <a:srgbClr val="FFFF00"/>
                          </a:highlight>
                          <a:latin typeface="Calibri" panose="020F0502020204030204" pitchFamily="34" charset="0"/>
                        </a:rPr>
                        <a:t>12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5096885"/>
                  </a:ext>
                </a:extLst>
              </a:tr>
              <a:tr h="192094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highlight>
                            <a:srgbClr val="FFFF00"/>
                          </a:highlight>
                          <a:latin typeface="Calibri" panose="020F0502020204030204" pitchFamily="34" charset="0"/>
                        </a:rPr>
                        <a:t>TSC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FFF00"/>
                          </a:highlight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highlight>
                            <a:srgbClr val="FFFF00"/>
                          </a:highlight>
                          <a:latin typeface="Calibri" panose="020F0502020204030204" pitchFamily="34" charset="0"/>
                        </a:rPr>
                        <a:t>12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71075554"/>
                  </a:ext>
                </a:extLst>
              </a:tr>
              <a:tr h="192094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FFF00"/>
                          </a:highlight>
                          <a:latin typeface="Calibri" panose="020F0502020204030204" pitchFamily="34" charset="0"/>
                        </a:rPr>
                        <a:t>SMARCB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FFF00"/>
                          </a:highlight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highlight>
                            <a:srgbClr val="FFFF00"/>
                          </a:highlight>
                          <a:latin typeface="Calibri" panose="020F0502020204030204" pitchFamily="34" charset="0"/>
                        </a:rPr>
                        <a:t>8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03937936"/>
                  </a:ext>
                </a:extLst>
              </a:tr>
              <a:tr h="192094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FFF00"/>
                          </a:highlight>
                          <a:latin typeface="Calibri" panose="020F0502020204030204" pitchFamily="34" charset="0"/>
                        </a:rPr>
                        <a:t>RET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FFF00"/>
                          </a:highlight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highlight>
                            <a:srgbClr val="FFFF00"/>
                          </a:highlight>
                          <a:latin typeface="Calibri" panose="020F0502020204030204" pitchFamily="34" charset="0"/>
                        </a:rPr>
                        <a:t>8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67764463"/>
                  </a:ext>
                </a:extLst>
              </a:tr>
              <a:tr h="192094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FFF00"/>
                          </a:highlight>
                          <a:latin typeface="Calibri" panose="020F0502020204030204" pitchFamily="34" charset="0"/>
                        </a:rPr>
                        <a:t>MET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FFF00"/>
                          </a:highlight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highlight>
                            <a:srgbClr val="FFFF00"/>
                          </a:highlight>
                          <a:latin typeface="Calibri" panose="020F0502020204030204" pitchFamily="34" charset="0"/>
                        </a:rPr>
                        <a:t>8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75465584"/>
                  </a:ext>
                </a:extLst>
              </a:tr>
              <a:tr h="192094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highlight>
                            <a:srgbClr val="FFFF00"/>
                          </a:highlight>
                          <a:latin typeface="Calibri" panose="020F0502020204030204" pitchFamily="34" charset="0"/>
                        </a:rPr>
                        <a:t>CBCF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FFF00"/>
                          </a:highlight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highlight>
                            <a:srgbClr val="FFFF00"/>
                          </a:highlight>
                          <a:latin typeface="Calibri" panose="020F0502020204030204" pitchFamily="34" charset="0"/>
                        </a:rPr>
                        <a:t>6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16398666"/>
                  </a:ext>
                </a:extLst>
              </a:tr>
              <a:tr h="192094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FFF00"/>
                          </a:highlight>
                          <a:latin typeface="Calibri" panose="020F0502020204030204" pitchFamily="34" charset="0"/>
                        </a:rPr>
                        <a:t>IDH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FFF00"/>
                          </a:highlight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highlight>
                            <a:srgbClr val="FFFF00"/>
                          </a:highlight>
                          <a:latin typeface="Calibri" panose="020F0502020204030204" pitchFamily="34" charset="0"/>
                        </a:rPr>
                        <a:t>6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28608755"/>
                  </a:ext>
                </a:extLst>
              </a:tr>
              <a:tr h="192094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FFF00"/>
                          </a:highlight>
                          <a:latin typeface="Calibri" panose="020F0502020204030204" pitchFamily="34" charset="0"/>
                        </a:rPr>
                        <a:t>JAK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FFF00"/>
                          </a:highlight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highlight>
                            <a:srgbClr val="FFFF00"/>
                          </a:highlight>
                          <a:latin typeface="Calibri" panose="020F0502020204030204" pitchFamily="34" charset="0"/>
                        </a:rPr>
                        <a:t>6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32991542"/>
                  </a:ext>
                </a:extLst>
              </a:tr>
              <a:tr h="192094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highlight>
                            <a:srgbClr val="FFFF00"/>
                          </a:highlight>
                          <a:latin typeface="Calibri" panose="020F0502020204030204" pitchFamily="34" charset="0"/>
                        </a:rPr>
                        <a:t>KMT2A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FFF00"/>
                          </a:highlight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highlight>
                            <a:srgbClr val="FFFF00"/>
                          </a:highlight>
                          <a:latin typeface="Calibri" panose="020F0502020204030204" pitchFamily="34" charset="0"/>
                        </a:rPr>
                        <a:t>6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46404265"/>
                  </a:ext>
                </a:extLst>
              </a:tr>
              <a:tr h="192094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FFF00"/>
                          </a:highlight>
                          <a:latin typeface="Calibri" panose="020F0502020204030204" pitchFamily="34" charset="0"/>
                        </a:rPr>
                        <a:t>SMARCA4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FFF00"/>
                          </a:highlight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highlight>
                            <a:srgbClr val="FFFF00"/>
                          </a:highlight>
                          <a:latin typeface="Calibri" panose="020F0502020204030204" pitchFamily="34" charset="0"/>
                        </a:rPr>
                        <a:t>6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1459258"/>
                  </a:ext>
                </a:extLst>
              </a:tr>
              <a:tr h="192094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FFF00"/>
                          </a:highlight>
                          <a:latin typeface="Calibri" panose="020F0502020204030204" pitchFamily="34" charset="0"/>
                        </a:rPr>
                        <a:t>SRC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FFF00"/>
                          </a:highlight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highlight>
                            <a:srgbClr val="FFFF00"/>
                          </a:highlight>
                          <a:latin typeface="Calibri" panose="020F0502020204030204" pitchFamily="34" charset="0"/>
                        </a:rPr>
                        <a:t>4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78230399"/>
                  </a:ext>
                </a:extLst>
              </a:tr>
              <a:tr h="192094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FFF00"/>
                          </a:highlight>
                          <a:latin typeface="Calibri" panose="020F0502020204030204" pitchFamily="34" charset="0"/>
                        </a:rPr>
                        <a:t>GNA1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FFF00"/>
                          </a:highlight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highlight>
                            <a:srgbClr val="FFFF00"/>
                          </a:highlight>
                          <a:latin typeface="Calibri" panose="020F0502020204030204" pitchFamily="34" charset="0"/>
                        </a:rPr>
                        <a:t>4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16293563"/>
                  </a:ext>
                </a:extLst>
              </a:tr>
              <a:tr h="192094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1" u="none" strike="noStrike" dirty="0">
                          <a:solidFill>
                            <a:srgbClr val="000000"/>
                          </a:solidFill>
                          <a:effectLst/>
                          <a:highlight>
                            <a:srgbClr val="FFFF00"/>
                          </a:highlight>
                          <a:latin typeface="Calibri" panose="020F0502020204030204" pitchFamily="34" charset="0"/>
                        </a:rPr>
                        <a:t>NOTCH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highlight>
                            <a:srgbClr val="FFFF00"/>
                          </a:highlight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highlight>
                            <a:srgbClr val="FFFF00"/>
                          </a:highlight>
                          <a:latin typeface="Calibri" panose="020F0502020204030204" pitchFamily="34" charset="0"/>
                        </a:rPr>
                        <a:t>4%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54623855"/>
                  </a:ext>
                </a:extLst>
              </a:tr>
            </a:tbl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4C50A80E-E48A-4BB2-A395-A94267D7E6BC}"/>
              </a:ext>
            </a:extLst>
          </p:cNvPr>
          <p:cNvSpPr txBox="1"/>
          <p:nvPr/>
        </p:nvSpPr>
        <p:spPr>
          <a:xfrm>
            <a:off x="3131124" y="6316206"/>
            <a:ext cx="6317676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i="0" u="none" strike="noStrike" dirty="0">
                <a:solidFill>
                  <a:srgbClr val="000000"/>
                </a:solidFill>
                <a:effectLst/>
                <a:highlight>
                  <a:srgbClr val="FFFF00"/>
                </a:highlight>
              </a:rPr>
              <a:t>*Informs the number of series that evaluated and reported the mutated gene. **It is the median value of all specified percentages reported in different series.</a:t>
            </a:r>
            <a:endParaRPr lang="en-US" sz="1200" b="1" dirty="0">
              <a:highlight>
                <a:srgbClr val="FFFF00"/>
              </a:highlight>
            </a:endParaRPr>
          </a:p>
        </p:txBody>
      </p:sp>
    </p:spTree>
    <p:extLst>
      <p:ext uri="{BB962C8B-B14F-4D97-AF65-F5344CB8AC3E}">
        <p14:creationId xmlns:p14="http://schemas.microsoft.com/office/powerpoint/2010/main" val="225845055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4">
            <a:extLst>
              <a:ext uri="{FF2B5EF4-FFF2-40B4-BE49-F238E27FC236}">
                <a16:creationId xmlns:a16="http://schemas.microsoft.com/office/drawing/2014/main" id="{43C4E136-38BD-4C99-8A08-1F5E6FC99B5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51965626"/>
              </p:ext>
            </p:extLst>
          </p:nvPr>
        </p:nvGraphicFramePr>
        <p:xfrm>
          <a:off x="1292087" y="818983"/>
          <a:ext cx="10038519" cy="5561784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078080">
                  <a:extLst>
                    <a:ext uri="{9D8B030D-6E8A-4147-A177-3AD203B41FA5}">
                      <a16:colId xmlns:a16="http://schemas.microsoft.com/office/drawing/2014/main" val="3988550619"/>
                    </a:ext>
                  </a:extLst>
                </a:gridCol>
                <a:gridCol w="1078080">
                  <a:extLst>
                    <a:ext uri="{9D8B030D-6E8A-4147-A177-3AD203B41FA5}">
                      <a16:colId xmlns:a16="http://schemas.microsoft.com/office/drawing/2014/main" val="1588756230"/>
                    </a:ext>
                  </a:extLst>
                </a:gridCol>
                <a:gridCol w="1078080">
                  <a:extLst>
                    <a:ext uri="{9D8B030D-6E8A-4147-A177-3AD203B41FA5}">
                      <a16:colId xmlns:a16="http://schemas.microsoft.com/office/drawing/2014/main" val="179675809"/>
                    </a:ext>
                  </a:extLst>
                </a:gridCol>
                <a:gridCol w="1078080">
                  <a:extLst>
                    <a:ext uri="{9D8B030D-6E8A-4147-A177-3AD203B41FA5}">
                      <a16:colId xmlns:a16="http://schemas.microsoft.com/office/drawing/2014/main" val="3163242072"/>
                    </a:ext>
                  </a:extLst>
                </a:gridCol>
                <a:gridCol w="779418">
                  <a:extLst>
                    <a:ext uri="{9D8B030D-6E8A-4147-A177-3AD203B41FA5}">
                      <a16:colId xmlns:a16="http://schemas.microsoft.com/office/drawing/2014/main" val="2015785146"/>
                    </a:ext>
                  </a:extLst>
                </a:gridCol>
                <a:gridCol w="922445">
                  <a:extLst>
                    <a:ext uri="{9D8B030D-6E8A-4147-A177-3AD203B41FA5}">
                      <a16:colId xmlns:a16="http://schemas.microsoft.com/office/drawing/2014/main" val="812283086"/>
                    </a:ext>
                  </a:extLst>
                </a:gridCol>
                <a:gridCol w="636391">
                  <a:extLst>
                    <a:ext uri="{9D8B030D-6E8A-4147-A177-3AD203B41FA5}">
                      <a16:colId xmlns:a16="http://schemas.microsoft.com/office/drawing/2014/main" val="2564280919"/>
                    </a:ext>
                  </a:extLst>
                </a:gridCol>
                <a:gridCol w="984355">
                  <a:extLst>
                    <a:ext uri="{9D8B030D-6E8A-4147-A177-3AD203B41FA5}">
                      <a16:colId xmlns:a16="http://schemas.microsoft.com/office/drawing/2014/main" val="1635545166"/>
                    </a:ext>
                  </a:extLst>
                </a:gridCol>
                <a:gridCol w="789414">
                  <a:extLst>
                    <a:ext uri="{9D8B030D-6E8A-4147-A177-3AD203B41FA5}">
                      <a16:colId xmlns:a16="http://schemas.microsoft.com/office/drawing/2014/main" val="1507040954"/>
                    </a:ext>
                  </a:extLst>
                </a:gridCol>
                <a:gridCol w="871890">
                  <a:extLst>
                    <a:ext uri="{9D8B030D-6E8A-4147-A177-3AD203B41FA5}">
                      <a16:colId xmlns:a16="http://schemas.microsoft.com/office/drawing/2014/main" val="1276212940"/>
                    </a:ext>
                  </a:extLst>
                </a:gridCol>
                <a:gridCol w="742286">
                  <a:extLst>
                    <a:ext uri="{9D8B030D-6E8A-4147-A177-3AD203B41FA5}">
                      <a16:colId xmlns:a16="http://schemas.microsoft.com/office/drawing/2014/main" val="593959140"/>
                    </a:ext>
                  </a:extLst>
                </a:gridCol>
              </a:tblGrid>
              <a:tr h="241775">
                <a:tc rowSpan="3"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Authors</a:t>
                      </a:r>
                    </a:p>
                    <a:p>
                      <a:pPr algn="ctr" fontAlgn="b"/>
                      <a:endParaRPr lang="en-US" sz="1200" b="1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3"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Year of publication</a:t>
                      </a:r>
                    </a:p>
                    <a:p>
                      <a:pPr algn="ctr" fontAlgn="b"/>
                      <a:endParaRPr lang="en-US" sz="1200" b="1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3"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Histologic Subtype</a:t>
                      </a:r>
                    </a:p>
                    <a:p>
                      <a:pPr algn="ctr" fontAlgn="b"/>
                      <a:endParaRPr lang="en-US" sz="1200" b="1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3"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Criteria in Tumor Cells</a:t>
                      </a:r>
                    </a:p>
                    <a:p>
                      <a:pPr algn="ctr" fontAlgn="b"/>
                      <a:endParaRPr lang="en-US" sz="1200" b="1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Tumor Cells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3">
                  <a:txBody>
                    <a:bodyPr/>
                    <a:lstStyle/>
                    <a:p>
                      <a:pPr algn="ctr" fontAlgn="b"/>
                      <a:r>
                        <a:rPr lang="it-IT" sz="1200" b="1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Criteria in Immune Stromal Cells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 gridSpan="3"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Immune Stromal Cells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162697402"/>
                  </a:ext>
                </a:extLst>
              </a:tr>
              <a:tr h="13269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Positive Cases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Negative Cases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Total Cases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3" vMerge="1">
                  <a:txBody>
                    <a:bodyPr/>
                    <a:lstStyle/>
                    <a:p>
                      <a:pPr algn="ctr" fontAlgn="b"/>
                      <a:endParaRPr lang="en-US" sz="1200" b="1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43823312"/>
                  </a:ext>
                </a:extLst>
              </a:tr>
              <a:tr h="530375">
                <a:tc vMerge="1">
                  <a:txBody>
                    <a:bodyPr/>
                    <a:lstStyle/>
                    <a:p>
                      <a:pPr algn="ctr" fontAlgn="b"/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Positive Cases</a:t>
                      </a:r>
                    </a:p>
                    <a:p>
                      <a:pPr algn="ctr" fontAlgn="b"/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Negative Cases</a:t>
                      </a:r>
                    </a:p>
                    <a:p>
                      <a:pPr algn="ctr" fontAlgn="b"/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Total Cases</a:t>
                      </a:r>
                    </a:p>
                    <a:p>
                      <a:pPr algn="ctr" fontAlgn="b"/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 fontAlgn="b"/>
                      <a:endParaRPr lang="en-US" sz="1800" b="0" i="0" u="none" strike="noStrike" dirty="0">
                        <a:solidFill>
                          <a:schemeClr val="bg1"/>
                        </a:solidFill>
                        <a:effectLst>
                          <a:outerShdw blurRad="38100" dist="38100" dir="2700000" algn="tl">
                            <a:srgbClr val="000000">
                              <a:alpha val="43137"/>
                            </a:srgbClr>
                          </a:outerShdw>
                        </a:effectLst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Positive Cases</a:t>
                      </a:r>
                    </a:p>
                    <a:p>
                      <a:pPr algn="ctr" fontAlgn="b"/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Negative Cases</a:t>
                      </a:r>
                    </a:p>
                    <a:p>
                      <a:pPr algn="ctr" fontAlgn="b"/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Total Cases</a:t>
                      </a:r>
                    </a:p>
                    <a:p>
                      <a:pPr algn="ctr" fontAlgn="b"/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96446326"/>
                  </a:ext>
                </a:extLst>
              </a:tr>
              <a:tr h="53037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Joneja</a:t>
                      </a:r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 et al.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2017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High Grade MBC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Cut-off ≥2+ intensity / ≥5% </a:t>
                      </a:r>
                      <a:r>
                        <a:rPr lang="en-US" sz="12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tumour</a:t>
                      </a:r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 cells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39 (54%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33 (46%)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72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NA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NA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NA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NA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45046405"/>
                  </a:ext>
                </a:extLst>
              </a:tr>
              <a:tr h="87792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Dill et al.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2017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Not  specified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Clear membranous staining present in ≥ 1% of tumor cells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2 (40%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3 (60%)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5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&gt;5% of peritumoral and </a:t>
                      </a:r>
                      <a:r>
                        <a:rPr lang="en-US" sz="12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intratumoral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4 (80%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1 (20%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99768953"/>
                  </a:ext>
                </a:extLst>
              </a:tr>
              <a:tr h="53037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Zhai et al.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2019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High Grade MBC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Cutoff ≥2+ intensity ≥5% tumor cells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0 (0%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18 (100%)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18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NA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NA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NA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NA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19404459"/>
                  </a:ext>
                </a:extLst>
              </a:tr>
              <a:tr h="7041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Vranic et al.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2020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Primary and Metastatic Spindle Cell Carcinoma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1% threshold in tumor cells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7 (33%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14 (67%)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21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Not  specified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2 (9.5%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19 (90.5%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2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06248712"/>
                  </a:ext>
                </a:extLst>
              </a:tr>
              <a:tr h="7041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Chao et al. 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2020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High Grade MBC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1% membranous or cytoplasmatic expression in tumor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30 (50%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30 (50%)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60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Some PD-L1 staining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40 (60%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20 (40%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60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23527021"/>
                  </a:ext>
                </a:extLst>
              </a:tr>
              <a:tr h="10517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Kalaw</a:t>
                      </a:r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 et al.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2020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Low- and High-Grade MBC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5% of cells displaying unequivocal cytoplasmic or membranous staining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107  (73%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39 (27%)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146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5% of cells displaying unequivocal cytoplasmic or membranous staining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91 (63%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53 (37%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144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20486030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92731F65-052F-4AFC-A0FB-9561FB085B55}"/>
              </a:ext>
            </a:extLst>
          </p:cNvPr>
          <p:cNvSpPr txBox="1"/>
          <p:nvPr/>
        </p:nvSpPr>
        <p:spPr>
          <a:xfrm>
            <a:off x="3710608" y="338733"/>
            <a:ext cx="7394712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Table </a:t>
            </a:r>
            <a:r>
              <a:rPr lang="en-US" sz="1200" b="1" dirty="0">
                <a:solidFill>
                  <a:srgbClr val="000000"/>
                </a:solidFill>
                <a:latin typeface="Calibri" panose="020F0502020204030204" pitchFamily="34" charset="0"/>
              </a:rPr>
              <a:t>4</a:t>
            </a:r>
            <a:r>
              <a:rPr lang="en-US" sz="1200" b="1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. PDL1 expression in Metaplastic Breast Cancer by Authors.</a:t>
            </a:r>
            <a:endParaRPr lang="en-US" sz="1200" b="1" dirty="0"/>
          </a:p>
        </p:txBody>
      </p:sp>
    </p:spTree>
    <p:extLst>
      <p:ext uri="{BB962C8B-B14F-4D97-AF65-F5344CB8AC3E}">
        <p14:creationId xmlns:p14="http://schemas.microsoft.com/office/powerpoint/2010/main" val="372560049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12">
            <a:extLst>
              <a:ext uri="{FF2B5EF4-FFF2-40B4-BE49-F238E27FC236}">
                <a16:creationId xmlns:a16="http://schemas.microsoft.com/office/drawing/2014/main" id="{4624A803-66DE-4195-FC6B-C6F445A81063}"/>
              </a:ext>
            </a:extLst>
          </p:cNvPr>
          <p:cNvSpPr txBox="1"/>
          <p:nvPr/>
        </p:nvSpPr>
        <p:spPr>
          <a:xfrm>
            <a:off x="3250393" y="184666"/>
            <a:ext cx="82392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Table 5. Clinical Trials in which cases of Metaplastic Breast Carcinoma have been included.</a:t>
            </a:r>
          </a:p>
        </p:txBody>
      </p:sp>
      <p:graphicFrame>
        <p:nvGraphicFramePr>
          <p:cNvPr id="4" name="Table 5">
            <a:extLst>
              <a:ext uri="{FF2B5EF4-FFF2-40B4-BE49-F238E27FC236}">
                <a16:creationId xmlns:a16="http://schemas.microsoft.com/office/drawing/2014/main" id="{8213C8F4-3479-4026-A4C0-E16AAD4C4F6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42960471"/>
              </p:ext>
            </p:extLst>
          </p:nvPr>
        </p:nvGraphicFramePr>
        <p:xfrm>
          <a:off x="1035878" y="975866"/>
          <a:ext cx="10305776" cy="4906268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576444">
                  <a:extLst>
                    <a:ext uri="{9D8B030D-6E8A-4147-A177-3AD203B41FA5}">
                      <a16:colId xmlns:a16="http://schemas.microsoft.com/office/drawing/2014/main" val="2090302183"/>
                    </a:ext>
                  </a:extLst>
                </a:gridCol>
                <a:gridCol w="2576444">
                  <a:extLst>
                    <a:ext uri="{9D8B030D-6E8A-4147-A177-3AD203B41FA5}">
                      <a16:colId xmlns:a16="http://schemas.microsoft.com/office/drawing/2014/main" val="2294482267"/>
                    </a:ext>
                  </a:extLst>
                </a:gridCol>
                <a:gridCol w="2576444">
                  <a:extLst>
                    <a:ext uri="{9D8B030D-6E8A-4147-A177-3AD203B41FA5}">
                      <a16:colId xmlns:a16="http://schemas.microsoft.com/office/drawing/2014/main" val="870955547"/>
                    </a:ext>
                  </a:extLst>
                </a:gridCol>
                <a:gridCol w="2576444">
                  <a:extLst>
                    <a:ext uri="{9D8B030D-6E8A-4147-A177-3AD203B41FA5}">
                      <a16:colId xmlns:a16="http://schemas.microsoft.com/office/drawing/2014/main" val="3730659935"/>
                    </a:ext>
                  </a:extLst>
                </a:gridCol>
              </a:tblGrid>
              <a:tr h="399098"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1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OFFICIAL TITLE AND CLINICALTRIALS.GOV IDENTIFIER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STATUS AND CONDITIONS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INTERVENTIONS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LOCATION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14497603"/>
                  </a:ext>
                </a:extLst>
              </a:tr>
              <a:tr h="830316"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eoadjuvant Chemotherapy Response in Metaplastic Carcinoma of Triple Negative Breast Cancer (NCT04549584) 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erminated (due to poor enrolled patients)</a:t>
                      </a:r>
                    </a:p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tual Enrollment: 3 participants. Metaplastic Breast Carcinoma</a:t>
                      </a:r>
                    </a:p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ndition.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iagnostic Test: Vimentin/pan CK stain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public of Korea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97448386"/>
                  </a:ext>
                </a:extLst>
              </a:tr>
              <a:tr h="83031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hase II Trial of </a:t>
                      </a:r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lpelisib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With </a:t>
                      </a:r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NOS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Inhibitor and Nab-paclitaxel in Patients With HER2 Negative Metastatic or Locally Advanced Metaplastic Breast Cancer (</a:t>
                      </a:r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pBC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) (NCT05660083)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cruiting</a:t>
                      </a:r>
                    </a:p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stimated Enrollment: 28 participants. HER2-negative Breast Cancer - Metastatic Breast Cancer - Metaplastic Breast Cancer – TNBC conditions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Drug: L-NMMA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he United States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88728084"/>
                  </a:ext>
                </a:extLst>
              </a:tr>
              <a:tr h="830316"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hase II Study for PIK3CA/PTEN-altered Advanced Metaplastic Breast Cancer Treated With MEN1611 Monotherapy or in Combination With </a:t>
                      </a:r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ribulin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(NCT05810870)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cruiting</a:t>
                      </a:r>
                    </a:p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stimated Enrollment: 28 participants. Breast Cancer - Advanced Breast Cancer - Metastatic Breast Cancer conditions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rug: MEN1611</a:t>
                      </a:r>
                      <a:b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</a:b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rug: </a:t>
                      </a:r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ribulin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pain</a:t>
                      </a:r>
                      <a:endParaRPr lang="es-E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35036086"/>
                  </a:ext>
                </a:extLst>
              </a:tr>
              <a:tr h="502290"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ivolumab and Ipilimumab in Treating Patients With Rare Tumors (NCT02834013)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tive, not recruiting </a:t>
                      </a:r>
                    </a:p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stimated Enrollment: 818 participants. Over 90 conditions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iological: Ipilimumab Biological: Nivolumab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he United States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34262497"/>
                  </a:ext>
                </a:extLst>
              </a:tr>
              <a:tr h="148636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A Phase III, Multicenter, Randomized, Placebo-Controlled Study of Atezolizumab (Anti-PD-L1 Antibody) in Combination With Nab-Paclitaxel Compared With Placebo With Nab-Paclitaxel for Patients With Previously Untreated Metastatic Triple-Negative Breast Cancer. (IMpassion130)</a:t>
                      </a:r>
                    </a:p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(NCT02425891)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erminated. Has results</a:t>
                      </a:r>
                    </a:p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tual Enrollment: 902 participants. TNBC condition.</a:t>
                      </a:r>
                    </a:p>
                    <a:p>
                      <a:pPr algn="ctr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ased on this Clinical Trial, the </a:t>
                      </a:r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DA 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as approved therapy with atezolizumab for TNBC containing 1% PD-L1 positive immune cells in the tumor biopsy. 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rug: Atezolizumab (MPDL3280A), an engineered anti-PDL1 antibody</a:t>
                      </a:r>
                      <a:b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</a:b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rug: Nab-Paclitaxel</a:t>
                      </a:r>
                      <a:b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</a:b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rug: Placebo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he United States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62505373"/>
                  </a:ext>
                </a:extLst>
              </a:tr>
            </a:tbl>
          </a:graphicData>
        </a:graphic>
      </p:graphicFrame>
      <p:sp>
        <p:nvSpPr>
          <p:cNvPr id="10" name="TextBox 12">
            <a:extLst>
              <a:ext uri="{FF2B5EF4-FFF2-40B4-BE49-F238E27FC236}">
                <a16:creationId xmlns:a16="http://schemas.microsoft.com/office/drawing/2014/main" id="{82A92E3D-FECF-4C0E-91B5-BC1BEBF489CA}"/>
              </a:ext>
            </a:extLst>
          </p:cNvPr>
          <p:cNvSpPr txBox="1"/>
          <p:nvPr/>
        </p:nvSpPr>
        <p:spPr>
          <a:xfrm>
            <a:off x="3765825" y="6396335"/>
            <a:ext cx="52191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Source: NIH. ClinicalTrials.gov  Available from: https://classic.clinicaltrials.gov/</a:t>
            </a:r>
          </a:p>
        </p:txBody>
      </p:sp>
    </p:spTree>
    <p:extLst>
      <p:ext uri="{BB962C8B-B14F-4D97-AF65-F5344CB8AC3E}">
        <p14:creationId xmlns:p14="http://schemas.microsoft.com/office/powerpoint/2010/main" val="366189043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12">
            <a:extLst>
              <a:ext uri="{FF2B5EF4-FFF2-40B4-BE49-F238E27FC236}">
                <a16:creationId xmlns:a16="http://schemas.microsoft.com/office/drawing/2014/main" id="{4624A803-66DE-4195-FC6B-C6F445A81063}"/>
              </a:ext>
            </a:extLst>
          </p:cNvPr>
          <p:cNvSpPr txBox="1"/>
          <p:nvPr/>
        </p:nvSpPr>
        <p:spPr>
          <a:xfrm>
            <a:off x="3250393" y="184666"/>
            <a:ext cx="82392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Table 5. Clinical Trials in which cases of Metaplastic Breast Carcinoma have been included.</a:t>
            </a:r>
          </a:p>
        </p:txBody>
      </p:sp>
      <p:graphicFrame>
        <p:nvGraphicFramePr>
          <p:cNvPr id="4" name="Table 5">
            <a:extLst>
              <a:ext uri="{FF2B5EF4-FFF2-40B4-BE49-F238E27FC236}">
                <a16:creationId xmlns:a16="http://schemas.microsoft.com/office/drawing/2014/main" id="{8213C8F4-3479-4026-A4C0-E16AAD4C4F6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4492520"/>
              </p:ext>
            </p:extLst>
          </p:nvPr>
        </p:nvGraphicFramePr>
        <p:xfrm>
          <a:off x="1183859" y="1038317"/>
          <a:ext cx="10305776" cy="4115753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576444">
                  <a:extLst>
                    <a:ext uri="{9D8B030D-6E8A-4147-A177-3AD203B41FA5}">
                      <a16:colId xmlns:a16="http://schemas.microsoft.com/office/drawing/2014/main" val="2090302183"/>
                    </a:ext>
                  </a:extLst>
                </a:gridCol>
                <a:gridCol w="2576444">
                  <a:extLst>
                    <a:ext uri="{9D8B030D-6E8A-4147-A177-3AD203B41FA5}">
                      <a16:colId xmlns:a16="http://schemas.microsoft.com/office/drawing/2014/main" val="2294482267"/>
                    </a:ext>
                  </a:extLst>
                </a:gridCol>
                <a:gridCol w="2576444">
                  <a:extLst>
                    <a:ext uri="{9D8B030D-6E8A-4147-A177-3AD203B41FA5}">
                      <a16:colId xmlns:a16="http://schemas.microsoft.com/office/drawing/2014/main" val="870955547"/>
                    </a:ext>
                  </a:extLst>
                </a:gridCol>
                <a:gridCol w="2576444">
                  <a:extLst>
                    <a:ext uri="{9D8B030D-6E8A-4147-A177-3AD203B41FA5}">
                      <a16:colId xmlns:a16="http://schemas.microsoft.com/office/drawing/2014/main" val="3730659935"/>
                    </a:ext>
                  </a:extLst>
                </a:gridCol>
              </a:tblGrid>
              <a:tr h="399098"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1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OFFICIAL TITLE AND CLINICALTRIALS.GOV IDENTIFIER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STATUS AND CONDITIONS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INTERVENTIONS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</a:rPr>
                        <a:t>LOCATION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14497603"/>
                  </a:ext>
                </a:extLst>
              </a:tr>
              <a:tr h="830316"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RTEMIS: A Robust TNBC Evaluation </a:t>
                      </a:r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raMework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to Improve Survival (NCT02276443)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cruiting</a:t>
                      </a:r>
                    </a:p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stimated Enrollment: 1000 participants. IBC and over 9 conditions</a:t>
                      </a:r>
                    </a:p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rug: Chemotherapy</a:t>
                      </a:r>
                      <a:b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</a:b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ther: Immunotherapy</a:t>
                      </a:r>
                      <a:b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</a:b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ther: Laboratory Biomarker Analysis</a:t>
                      </a:r>
                      <a:b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</a:b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ocedure: Lymph Node Biopsy</a:t>
                      </a:r>
                      <a:b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</a:b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ocedure: Ultrasonography</a:t>
                      </a:r>
                    </a:p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he United States</a:t>
                      </a:r>
                    </a:p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97448386"/>
                  </a:ext>
                </a:extLst>
              </a:tr>
              <a:tr h="83031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 Randomized, Double-Blind, Phase III Study of Pembrolizumab (MK-3475) Plus Chemotherapy vs Placebo Plus Chemotherapy for Previously Untreated Locally Recurrent Inoperable or Metastatic Triple Negative Breast Cancer - (KEYNOTE-355)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erminated. Has results</a:t>
                      </a:r>
                    </a:p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tual Enrollment: 882 participants</a:t>
                      </a:r>
                    </a:p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NBC conditions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iological: Pembrolizumab</a:t>
                      </a:r>
                    </a:p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rug: Nab-paclitaxel</a:t>
                      </a:r>
                    </a:p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rug: Paclitaxel</a:t>
                      </a:r>
                    </a:p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rug: Gemcitabine</a:t>
                      </a:r>
                    </a:p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rug: Carboplatin</a:t>
                      </a:r>
                    </a:p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rug: </a:t>
                      </a:r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rmale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Saline Solution 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 location data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88728084"/>
                  </a:ext>
                </a:extLst>
              </a:tr>
              <a:tr h="830316"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 Phase III, Randomized, Double-blind Study to Evaluate Pembrolizumab Plus Chemotherapy vs Placebo Plus Chemotherapy as Neoadjuvant Therapy and Pembrolizumab vs Placebo as Adjuvant Therapy for Triple Negative Breast Cancer (TNBC) (MK-3475-522/KEYNOTE-522)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tive, not recruiting.</a:t>
                      </a:r>
                    </a:p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tual Enrollment : 174 participants</a:t>
                      </a:r>
                    </a:p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riple Negative Breast Neoplasms conditions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iological: Pembrolizumab</a:t>
                      </a:r>
                    </a:p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rug: Carboplatin</a:t>
                      </a:r>
                    </a:p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rug: Paclitaxel</a:t>
                      </a:r>
                    </a:p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rug: Doxorubicin</a:t>
                      </a:r>
                    </a:p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rug: </a:t>
                      </a:r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pirubicin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rug: Cyclophosphamide</a:t>
                      </a:r>
                    </a:p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rug: Placebo</a:t>
                      </a:r>
                    </a:p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iological: Granulocyte colony stimulating factor: Filgrastim or </a:t>
                      </a:r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egfilgastrim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he</a:t>
                      </a:r>
                      <a:r>
                        <a:rPr lang="es-E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</a:t>
                      </a:r>
                      <a:r>
                        <a:rPr lang="es-E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nited</a:t>
                      </a:r>
                      <a:r>
                        <a:rPr lang="es-E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</a:t>
                      </a:r>
                      <a:r>
                        <a:rPr lang="es-E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tates</a:t>
                      </a:r>
                      <a:r>
                        <a:rPr lang="es-E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. Australia. </a:t>
                      </a:r>
                      <a:r>
                        <a:rPr lang="es-E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razil</a:t>
                      </a:r>
                      <a:r>
                        <a:rPr lang="es-E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. </a:t>
                      </a:r>
                      <a:r>
                        <a:rPr lang="es-E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anada</a:t>
                      </a:r>
                      <a:r>
                        <a:rPr lang="es-E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. Colombia. France. </a:t>
                      </a:r>
                      <a:r>
                        <a:rPr lang="es-E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ermany</a:t>
                      </a:r>
                      <a:r>
                        <a:rPr lang="es-E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. </a:t>
                      </a:r>
                      <a:r>
                        <a:rPr lang="es-E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reland</a:t>
                      </a:r>
                      <a:r>
                        <a:rPr lang="es-E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. Israel. </a:t>
                      </a:r>
                      <a:r>
                        <a:rPr lang="es-E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taly</a:t>
                      </a:r>
                      <a:r>
                        <a:rPr lang="es-E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. </a:t>
                      </a:r>
                      <a:r>
                        <a:rPr lang="es-E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Japan</a:t>
                      </a:r>
                      <a:r>
                        <a:rPr lang="es-E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. </a:t>
                      </a:r>
                      <a:r>
                        <a:rPr lang="es-E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orea</a:t>
                      </a:r>
                      <a:r>
                        <a:rPr lang="es-E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. </a:t>
                      </a:r>
                      <a:r>
                        <a:rPr lang="es-E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oland</a:t>
                      </a:r>
                      <a:r>
                        <a:rPr lang="es-E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. Portugal. </a:t>
                      </a:r>
                      <a:r>
                        <a:rPr lang="es-E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ussian</a:t>
                      </a:r>
                      <a:r>
                        <a:rPr lang="es-E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</a:t>
                      </a:r>
                      <a:r>
                        <a:rPr lang="es-E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ederation</a:t>
                      </a:r>
                      <a:r>
                        <a:rPr lang="es-E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. </a:t>
                      </a:r>
                      <a:r>
                        <a:rPr lang="es-E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ingapore</a:t>
                      </a:r>
                      <a:r>
                        <a:rPr lang="es-E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. </a:t>
                      </a:r>
                      <a:r>
                        <a:rPr lang="es-E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pain</a:t>
                      </a:r>
                      <a:r>
                        <a:rPr lang="es-E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. </a:t>
                      </a:r>
                      <a:r>
                        <a:rPr lang="es-E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weden</a:t>
                      </a:r>
                      <a:r>
                        <a:rPr lang="es-E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. </a:t>
                      </a:r>
                      <a:r>
                        <a:rPr lang="es-E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aiwan</a:t>
                      </a:r>
                      <a:r>
                        <a:rPr lang="es-E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. </a:t>
                      </a:r>
                      <a:r>
                        <a:rPr lang="es-E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urkey</a:t>
                      </a:r>
                      <a:r>
                        <a:rPr lang="es-E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. </a:t>
                      </a:r>
                      <a:r>
                        <a:rPr lang="es-E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nited</a:t>
                      </a:r>
                      <a:r>
                        <a:rPr lang="es-E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</a:t>
                      </a:r>
                      <a:r>
                        <a:rPr lang="es-E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ingdom</a:t>
                      </a:r>
                      <a:endParaRPr lang="es-E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35036086"/>
                  </a:ext>
                </a:extLst>
              </a:tr>
            </a:tbl>
          </a:graphicData>
        </a:graphic>
      </p:graphicFrame>
      <p:sp>
        <p:nvSpPr>
          <p:cNvPr id="10" name="TextBox 12">
            <a:extLst>
              <a:ext uri="{FF2B5EF4-FFF2-40B4-BE49-F238E27FC236}">
                <a16:creationId xmlns:a16="http://schemas.microsoft.com/office/drawing/2014/main" id="{82A92E3D-FECF-4C0E-91B5-BC1BEBF489CA}"/>
              </a:ext>
            </a:extLst>
          </p:cNvPr>
          <p:cNvSpPr txBox="1"/>
          <p:nvPr/>
        </p:nvSpPr>
        <p:spPr>
          <a:xfrm>
            <a:off x="3765825" y="6396335"/>
            <a:ext cx="52191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Source: NIH. ClinicalTrials.gov  Available from: https://classic.clinicaltrials.gov/</a:t>
            </a:r>
          </a:p>
        </p:txBody>
      </p:sp>
    </p:spTree>
    <p:extLst>
      <p:ext uri="{BB962C8B-B14F-4D97-AF65-F5344CB8AC3E}">
        <p14:creationId xmlns:p14="http://schemas.microsoft.com/office/powerpoint/2010/main" val="155039255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046</TotalTime>
  <Words>1416</Words>
  <Application>Microsoft Office PowerPoint</Application>
  <PresentationFormat>Widescreen</PresentationFormat>
  <Paragraphs>404</Paragraphs>
  <Slides>7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1" baseType="lpstr">
      <vt:lpstr>Arial</vt:lpstr>
      <vt:lpstr>Calibri</vt:lpstr>
      <vt:lpstr>Calibri Light</vt:lpstr>
      <vt:lpstr>Office Theme</vt:lpstr>
      <vt:lpstr>Translational Aspects in Metaplastic Breast Carcinoma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arrientos Toro,Elizve N</dc:creator>
  <cp:lastModifiedBy>Barrientos Toro,Elizve N</cp:lastModifiedBy>
  <cp:revision>46</cp:revision>
  <dcterms:created xsi:type="dcterms:W3CDTF">2023-10-04T19:11:08Z</dcterms:created>
  <dcterms:modified xsi:type="dcterms:W3CDTF">2024-03-29T14:30:07Z</dcterms:modified>
</cp:coreProperties>
</file>